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4"/>
  </p:sldMasterIdLst>
  <p:sldIdLst>
    <p:sldId id="256" r:id="rId5"/>
    <p:sldId id="257" r:id="rId6"/>
  </p:sldIdLst>
  <p:sldSz cx="7561263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esnulevicius, Dr. Konstantin" initials="CK" lastIdx="1" clrIdx="0">
    <p:extLst>
      <p:ext uri="{19B8F6BF-5375-455C-9EA6-DF929625EA0E}">
        <p15:presenceInfo xmlns:p15="http://schemas.microsoft.com/office/powerpoint/2012/main" userId="S::konstantin.cesnulevicius@heel.com::a0fdf21e-2a91-48e5-9c7b-fc2d47b2e48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8" autoAdjust="0"/>
    <p:restoredTop sz="94660"/>
  </p:normalViewPr>
  <p:slideViewPr>
    <p:cSldViewPr snapToGrid="0">
      <p:cViewPr varScale="1">
        <p:scale>
          <a:sx n="74" d="100"/>
          <a:sy n="74" d="100"/>
        </p:scale>
        <p:origin x="306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1749795"/>
            <a:ext cx="6427074" cy="3722335"/>
          </a:xfrm>
        </p:spPr>
        <p:txBody>
          <a:bodyPr anchor="b"/>
          <a:lstStyle>
            <a:lvl1pPr algn="ctr"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158" y="5615678"/>
            <a:ext cx="5670947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059" indent="0" algn="ctr">
              <a:buNone/>
              <a:defRPr sz="1654"/>
            </a:lvl2pPr>
            <a:lvl3pPr marL="756117" indent="0" algn="ctr">
              <a:buNone/>
              <a:defRPr sz="1488"/>
            </a:lvl3pPr>
            <a:lvl4pPr marL="1134176" indent="0" algn="ctr">
              <a:buNone/>
              <a:defRPr sz="1323"/>
            </a:lvl4pPr>
            <a:lvl5pPr marL="1512235" indent="0" algn="ctr">
              <a:buNone/>
              <a:defRPr sz="1323"/>
            </a:lvl5pPr>
            <a:lvl6pPr marL="1890293" indent="0" algn="ctr">
              <a:buNone/>
              <a:defRPr sz="1323"/>
            </a:lvl6pPr>
            <a:lvl7pPr marL="2268352" indent="0" algn="ctr">
              <a:buNone/>
              <a:defRPr sz="1323"/>
            </a:lvl7pPr>
            <a:lvl8pPr marL="2646411" indent="0" algn="ctr">
              <a:buNone/>
              <a:defRPr sz="1323"/>
            </a:lvl8pPr>
            <a:lvl9pPr marL="3024469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246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75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1029" y="569240"/>
            <a:ext cx="1630397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837" y="569240"/>
            <a:ext cx="4796676" cy="9060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818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21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899" y="2665532"/>
            <a:ext cx="6521589" cy="4447496"/>
          </a:xfrm>
        </p:spPr>
        <p:txBody>
          <a:bodyPr anchor="b"/>
          <a:lstStyle>
            <a:lvl1pPr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899" y="7155103"/>
            <a:ext cx="6521589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05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117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417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235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29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35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641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44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77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837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889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660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569242"/>
            <a:ext cx="6521589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823" y="2620980"/>
            <a:ext cx="3198768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823" y="3905482"/>
            <a:ext cx="3198768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890" y="2620980"/>
            <a:ext cx="3214522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890" y="3905482"/>
            <a:ext cx="3214522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725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549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434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522" y="1539425"/>
            <a:ext cx="3827889" cy="7598117"/>
          </a:xfrm>
        </p:spPr>
        <p:txBody>
          <a:bodyPr/>
          <a:lstStyle>
            <a:lvl1pPr>
              <a:defRPr sz="2646"/>
            </a:lvl1pPr>
            <a:lvl2pPr>
              <a:defRPr sz="2315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900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4522" y="1539425"/>
            <a:ext cx="3827889" cy="7598117"/>
          </a:xfrm>
        </p:spPr>
        <p:txBody>
          <a:bodyPr anchor="t"/>
          <a:lstStyle>
            <a:lvl1pPr marL="0" indent="0">
              <a:buNone/>
              <a:defRPr sz="2646"/>
            </a:lvl1pPr>
            <a:lvl2pPr marL="378059" indent="0">
              <a:buNone/>
              <a:defRPr sz="2315"/>
            </a:lvl2pPr>
            <a:lvl3pPr marL="756117" indent="0">
              <a:buNone/>
              <a:defRPr sz="1985"/>
            </a:lvl3pPr>
            <a:lvl4pPr marL="1134176" indent="0">
              <a:buNone/>
              <a:defRPr sz="1654"/>
            </a:lvl4pPr>
            <a:lvl5pPr marL="1512235" indent="0">
              <a:buNone/>
              <a:defRPr sz="1654"/>
            </a:lvl5pPr>
            <a:lvl6pPr marL="1890293" indent="0">
              <a:buNone/>
              <a:defRPr sz="1654"/>
            </a:lvl6pPr>
            <a:lvl7pPr marL="2268352" indent="0">
              <a:buNone/>
              <a:defRPr sz="1654"/>
            </a:lvl7pPr>
            <a:lvl8pPr marL="2646411" indent="0">
              <a:buNone/>
              <a:defRPr sz="1654"/>
            </a:lvl8pPr>
            <a:lvl9pPr marL="3024469" indent="0">
              <a:buNone/>
              <a:defRPr sz="165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90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837" y="569242"/>
            <a:ext cx="652158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837" y="2846200"/>
            <a:ext cx="652158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837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1EA4E6-7DC1-4956-B81F-C1E937D094C2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669" y="9909729"/>
            <a:ext cx="2551926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0142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007D7-FB11-4A2F-8098-808AC02FA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948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6117" rtl="0" eaLnBrk="1" latinLnBrk="0" hangingPunct="1">
        <a:lnSpc>
          <a:spcPct val="90000"/>
        </a:lnSpc>
        <a:spcBef>
          <a:spcPct val="0"/>
        </a:spcBef>
        <a:buNone/>
        <a:defRPr sz="36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29" indent="-189029" algn="l" defTabSz="756117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88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147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205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1264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9323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7381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5440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3499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805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6117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4176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2235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90293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8352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6411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446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8DCD436-3FE5-44D3-A56F-DC6001BCB7FD}"/>
              </a:ext>
            </a:extLst>
          </p:cNvPr>
          <p:cNvSpPr/>
          <p:nvPr/>
        </p:nvSpPr>
        <p:spPr>
          <a:xfrm>
            <a:off x="3572352" y="5022107"/>
            <a:ext cx="276038" cy="57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157" dirty="0"/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D22BD13-1C92-4129-848E-9E5D373157C7}"/>
              </a:ext>
            </a:extLst>
          </p:cNvPr>
          <p:cNvSpPr/>
          <p:nvPr/>
        </p:nvSpPr>
        <p:spPr>
          <a:xfrm>
            <a:off x="3572352" y="5022107"/>
            <a:ext cx="276038" cy="57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157" dirty="0"/>
              <a:t> 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11BF342-00B4-4D0D-8017-15225EA92B98}"/>
              </a:ext>
            </a:extLst>
          </p:cNvPr>
          <p:cNvSpPr/>
          <p:nvPr/>
        </p:nvSpPr>
        <p:spPr>
          <a:xfrm>
            <a:off x="1108422" y="423610"/>
            <a:ext cx="3266124" cy="761154"/>
          </a:xfrm>
          <a:prstGeom prst="rect">
            <a:avLst/>
          </a:prstGeom>
          <a:gradFill rotWithShape="1">
            <a:gsLst>
              <a:gs pos="0">
                <a:srgbClr val="9C9C9C">
                  <a:tint val="50000"/>
                  <a:satMod val="300000"/>
                </a:srgbClr>
              </a:gs>
              <a:gs pos="35000">
                <a:srgbClr val="9C9C9C">
                  <a:tint val="37000"/>
                  <a:satMod val="300000"/>
                </a:srgbClr>
              </a:gs>
              <a:gs pos="100000">
                <a:srgbClr val="9C9C9C">
                  <a:tint val="15000"/>
                  <a:satMod val="350000"/>
                </a:srgbClr>
              </a:gs>
            </a:gsLst>
            <a:lin ang="16200000" scaled="1"/>
          </a:gradFill>
          <a:ln w="9525" cap="flat" cmpd="sng" algn="ctr">
            <a:solidFill>
              <a:srgbClr val="9C9C9C">
                <a:shade val="95000"/>
                <a:satMod val="105000"/>
              </a:srgb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rPr>
              <a:t>Samples from 19 patients</a:t>
            </a:r>
          </a:p>
        </p:txBody>
      </p: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4C12B99B-1970-4B51-8013-1DD159745345}"/>
              </a:ext>
            </a:extLst>
          </p:cNvPr>
          <p:cNvGrpSpPr/>
          <p:nvPr/>
        </p:nvGrpSpPr>
        <p:grpSpPr>
          <a:xfrm>
            <a:off x="269919" y="1719828"/>
            <a:ext cx="7017844" cy="762368"/>
            <a:chOff x="269919" y="1719828"/>
            <a:chExt cx="7017844" cy="762368"/>
          </a:xfrm>
        </p:grpSpPr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052C6D05-840D-4609-818E-76C3C7350CDC}"/>
                </a:ext>
              </a:extLst>
            </p:cNvPr>
            <p:cNvSpPr/>
            <p:nvPr/>
          </p:nvSpPr>
          <p:spPr>
            <a:xfrm>
              <a:off x="269919" y="1719828"/>
              <a:ext cx="2163917" cy="76236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ranscriptome analysis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mples from 10 patients</a:t>
              </a: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BC2B214A-3EB8-4ECF-B39C-89301FB9667C}"/>
                </a:ext>
              </a:extLst>
            </p:cNvPr>
            <p:cNvSpPr/>
            <p:nvPr/>
          </p:nvSpPr>
          <p:spPr>
            <a:xfrm>
              <a:off x="2836744" y="1719828"/>
              <a:ext cx="4451019" cy="76236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Protein analysis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mples from 9 patients</a:t>
              </a:r>
            </a:p>
          </p:txBody>
        </p: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F42C0652-EE51-43B0-B05E-C54AFFF8B3E6}"/>
              </a:ext>
            </a:extLst>
          </p:cNvPr>
          <p:cNvGrpSpPr/>
          <p:nvPr/>
        </p:nvGrpSpPr>
        <p:grpSpPr>
          <a:xfrm>
            <a:off x="269919" y="4588648"/>
            <a:ext cx="7021425" cy="762368"/>
            <a:chOff x="269919" y="4588648"/>
            <a:chExt cx="7021425" cy="762368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A6DDE364-4E3B-48E8-8636-4A17CE26C82C}"/>
                </a:ext>
              </a:extLst>
            </p:cNvPr>
            <p:cNvSpPr/>
            <p:nvPr/>
          </p:nvSpPr>
          <p:spPr>
            <a:xfrm>
              <a:off x="269919" y="4588648"/>
              <a:ext cx="2163917" cy="76236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10 monolayer cultures</a:t>
              </a: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69DA57C0-9678-4CF1-A9FB-87A76F554A42}"/>
                </a:ext>
              </a:extLst>
            </p:cNvPr>
            <p:cNvSpPr/>
            <p:nvPr/>
          </p:nvSpPr>
          <p:spPr>
            <a:xfrm>
              <a:off x="2836744" y="4588648"/>
              <a:ext cx="2163729" cy="76236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6 monolayer cultures</a:t>
              </a: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E6E30112-581D-4ADA-A8D0-FBA964C1521F}"/>
                </a:ext>
              </a:extLst>
            </p:cNvPr>
            <p:cNvSpPr/>
            <p:nvPr/>
          </p:nvSpPr>
          <p:spPr>
            <a:xfrm>
              <a:off x="5127615" y="4588648"/>
              <a:ext cx="2163729" cy="76236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4 alginate beads cultures* 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1999AE5D-8493-4FC1-8023-C700E4642687}"/>
              </a:ext>
            </a:extLst>
          </p:cNvPr>
          <p:cNvGrpSpPr/>
          <p:nvPr/>
        </p:nvGrpSpPr>
        <p:grpSpPr>
          <a:xfrm>
            <a:off x="2836744" y="3098939"/>
            <a:ext cx="4454600" cy="872965"/>
            <a:chOff x="2836744" y="3098939"/>
            <a:chExt cx="4454600" cy="872965"/>
          </a:xfrm>
        </p:grpSpPr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66E62455-D7DF-4811-9C62-E8093A142238}"/>
                </a:ext>
              </a:extLst>
            </p:cNvPr>
            <p:cNvSpPr/>
            <p:nvPr/>
          </p:nvSpPr>
          <p:spPr>
            <a:xfrm>
              <a:off x="2836744" y="3098939"/>
              <a:ext cx="1368366" cy="872965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Monolayer cultures only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2 patients </a:t>
              </a: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9F334EF6-A261-4072-A600-31728655DC48}"/>
                </a:ext>
              </a:extLst>
            </p:cNvPr>
            <p:cNvSpPr/>
            <p:nvPr/>
          </p:nvSpPr>
          <p:spPr>
            <a:xfrm>
              <a:off x="5922978" y="3098939"/>
              <a:ext cx="1368366" cy="87296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Alginate beads culture only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3 patients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161225DE-1A61-41D7-AE59-BFF384833C8B}"/>
                </a:ext>
              </a:extLst>
            </p:cNvPr>
            <p:cNvSpPr/>
            <p:nvPr/>
          </p:nvSpPr>
          <p:spPr>
            <a:xfrm>
              <a:off x="4379861" y="3098939"/>
              <a:ext cx="1368366" cy="872965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Both monolayer and alginate beads culture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4 patients</a:t>
              </a:r>
            </a:p>
          </p:txBody>
        </p:sp>
      </p:grp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F64C5B5A-DDD4-4802-8E0D-350DF5A6C715}"/>
              </a:ext>
            </a:extLst>
          </p:cNvPr>
          <p:cNvCxnSpPr>
            <a:cxnSpLocks/>
          </p:cNvCxnSpPr>
          <p:nvPr/>
        </p:nvCxnSpPr>
        <p:spPr>
          <a:xfrm rot="3600000">
            <a:off x="1966059" y="1263552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A03A4EE7-B225-4CE0-9049-5A3E2D1282D5}"/>
              </a:ext>
            </a:extLst>
          </p:cNvPr>
          <p:cNvGrpSpPr/>
          <p:nvPr/>
        </p:nvGrpSpPr>
        <p:grpSpPr>
          <a:xfrm>
            <a:off x="269919" y="5967759"/>
            <a:ext cx="7021425" cy="1224000"/>
            <a:chOff x="269919" y="5967759"/>
            <a:chExt cx="7021425" cy="1224000"/>
          </a:xfrm>
        </p:grpSpPr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6E43EB35-E246-42F6-B91F-07B8C8D2F9D3}"/>
                </a:ext>
              </a:extLst>
            </p:cNvPr>
            <p:cNvSpPr/>
            <p:nvPr/>
          </p:nvSpPr>
          <p:spPr>
            <a:xfrm>
              <a:off x="269919" y="5967759"/>
              <a:ext cx="2163917" cy="1224000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reatment conditions: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line-Control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line-control + IL-1</a:t>
              </a:r>
              <a:r>
                <a:rPr kumimoji="0" lang="el-GR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β</a:t>
              </a:r>
              <a:endParaRPr kumimoji="0" lang="de-DE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endParaRP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10% (v/v)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10% (v/v) + IL-1β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20% (v/v) 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20% (v/v) + IL-1β</a:t>
              </a:r>
              <a:endParaRPr kumimoji="0" lang="el-GR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815A2948-6922-4515-A2DB-C89065B12719}"/>
                </a:ext>
              </a:extLst>
            </p:cNvPr>
            <p:cNvSpPr/>
            <p:nvPr/>
          </p:nvSpPr>
          <p:spPr>
            <a:xfrm>
              <a:off x="2836744" y="5967759"/>
              <a:ext cx="2163917" cy="54582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reatment conditions: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line-Control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20% (v/v) </a:t>
              </a: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06BCC001-A50B-4009-91EA-83FC91AAE264}"/>
                </a:ext>
              </a:extLst>
            </p:cNvPr>
            <p:cNvSpPr/>
            <p:nvPr/>
          </p:nvSpPr>
          <p:spPr>
            <a:xfrm>
              <a:off x="5127427" y="5967759"/>
              <a:ext cx="2163917" cy="54582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reatment conditions: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Saline-Control</a:t>
              </a:r>
            </a:p>
            <a:p>
              <a:pPr marL="228600" marR="0" lvl="0" indent="-22860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+mj-lt"/>
                <a:buAutoNum type="arabicPeriod"/>
                <a:tabLst/>
                <a:defRPr/>
              </a:pPr>
              <a:r>
                <a:rPr kumimoji="0" lang="en-GB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Ze14 20% (v/v) </a:t>
              </a:r>
            </a:p>
          </p:txBody>
        </p:sp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E307F13C-B3D9-40BD-88D0-2931328263E1}"/>
              </a:ext>
            </a:extLst>
          </p:cNvPr>
          <p:cNvGrpSpPr/>
          <p:nvPr/>
        </p:nvGrpSpPr>
        <p:grpSpPr>
          <a:xfrm>
            <a:off x="269919" y="7659121"/>
            <a:ext cx="7021425" cy="762368"/>
            <a:chOff x="141375" y="9560756"/>
            <a:chExt cx="8866795" cy="962734"/>
          </a:xfrm>
        </p:grpSpPr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3F88CE57-B99E-4295-87A6-99BF53474CDE}"/>
                </a:ext>
              </a:extLst>
            </p:cNvPr>
            <p:cNvSpPr/>
            <p:nvPr/>
          </p:nvSpPr>
          <p:spPr>
            <a:xfrm>
              <a:off x="6275533" y="9560756"/>
              <a:ext cx="2732637" cy="96273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ime points of sample collection for analysis after incubation: 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Day 3-7-10-14-17-21-24-28</a:t>
              </a: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F336A0F2-00A8-4E46-BA03-1CEA001535FE}"/>
                </a:ext>
              </a:extLst>
            </p:cNvPr>
            <p:cNvSpPr/>
            <p:nvPr/>
          </p:nvSpPr>
          <p:spPr>
            <a:xfrm>
              <a:off x="141375" y="9560756"/>
              <a:ext cx="2732637" cy="96273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ime points of sample collection for analysis after incubation: 24 h</a:t>
              </a: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3DEB179C-76DF-4B8A-8564-B04C635C3DBA}"/>
                </a:ext>
              </a:extLst>
            </p:cNvPr>
            <p:cNvSpPr/>
            <p:nvPr/>
          </p:nvSpPr>
          <p:spPr>
            <a:xfrm>
              <a:off x="3382812" y="9560756"/>
              <a:ext cx="2732637" cy="962734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Time points of sample collection for analysis after incubation: 24 h and 72 h </a:t>
              </a:r>
            </a:p>
          </p:txBody>
        </p:sp>
      </p:grp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9B81D10F-A378-4C15-9C62-201C7F3E106B}"/>
              </a:ext>
            </a:extLst>
          </p:cNvPr>
          <p:cNvCxnSpPr/>
          <p:nvPr/>
        </p:nvCxnSpPr>
        <p:spPr>
          <a:xfrm>
            <a:off x="3178585" y="1266072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829D0327-899F-4CA6-91DD-C91A2DC625C3}"/>
              </a:ext>
            </a:extLst>
          </p:cNvPr>
          <p:cNvCxnSpPr/>
          <p:nvPr/>
        </p:nvCxnSpPr>
        <p:spPr>
          <a:xfrm>
            <a:off x="5986386" y="2587504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35BF8732-F56A-425E-8B5D-2B448300B539}"/>
              </a:ext>
            </a:extLst>
          </p:cNvPr>
          <p:cNvCxnSpPr>
            <a:cxnSpLocks/>
          </p:cNvCxnSpPr>
          <p:nvPr/>
        </p:nvCxnSpPr>
        <p:spPr>
          <a:xfrm rot="3600000">
            <a:off x="3847771" y="2590024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D74A3FB0-E5F4-4702-9575-BC416704FDAE}"/>
              </a:ext>
            </a:extLst>
          </p:cNvPr>
          <p:cNvCxnSpPr/>
          <p:nvPr/>
        </p:nvCxnSpPr>
        <p:spPr>
          <a:xfrm>
            <a:off x="5062253" y="2577569"/>
            <a:ext cx="0" cy="456122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733A282C-6B5E-4F96-9BE1-DD6BDC0085DC}"/>
              </a:ext>
            </a:extLst>
          </p:cNvPr>
          <p:cNvCxnSpPr>
            <a:cxnSpLocks/>
          </p:cNvCxnSpPr>
          <p:nvPr/>
        </p:nvCxnSpPr>
        <p:spPr>
          <a:xfrm rot="3600000">
            <a:off x="4357721" y="4071180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74317A00-A051-4172-BF13-8F1BA5A48287}"/>
              </a:ext>
            </a:extLst>
          </p:cNvPr>
          <p:cNvCxnSpPr/>
          <p:nvPr/>
        </p:nvCxnSpPr>
        <p:spPr>
          <a:xfrm>
            <a:off x="5570247" y="4073700"/>
            <a:ext cx="243979" cy="432668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AE506C2A-F728-44C9-84BE-B9183D75AB3D}"/>
              </a:ext>
            </a:extLst>
          </p:cNvPr>
          <p:cNvCxnSpPr/>
          <p:nvPr/>
        </p:nvCxnSpPr>
        <p:spPr>
          <a:xfrm>
            <a:off x="6607161" y="4060130"/>
            <a:ext cx="0" cy="499625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36659934-8032-47DB-A741-D93892A4411E}"/>
              </a:ext>
            </a:extLst>
          </p:cNvPr>
          <p:cNvCxnSpPr/>
          <p:nvPr/>
        </p:nvCxnSpPr>
        <p:spPr>
          <a:xfrm>
            <a:off x="3520927" y="4060130"/>
            <a:ext cx="0" cy="499625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8C9F4A55-1FA7-4443-8828-D6D1192FB323}"/>
              </a:ext>
            </a:extLst>
          </p:cNvPr>
          <p:cNvCxnSpPr/>
          <p:nvPr/>
        </p:nvCxnSpPr>
        <p:spPr>
          <a:xfrm>
            <a:off x="1351877" y="2577569"/>
            <a:ext cx="0" cy="1938519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2075C23C-3D78-40F9-ABD9-95A39FC376A8}"/>
              </a:ext>
            </a:extLst>
          </p:cNvPr>
          <p:cNvCxnSpPr/>
          <p:nvPr/>
        </p:nvCxnSpPr>
        <p:spPr>
          <a:xfrm>
            <a:off x="3918608" y="5428649"/>
            <a:ext cx="0" cy="499625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08225442-A923-4DA4-B25E-6778EA3B533D}"/>
              </a:ext>
            </a:extLst>
          </p:cNvPr>
          <p:cNvCxnSpPr/>
          <p:nvPr/>
        </p:nvCxnSpPr>
        <p:spPr>
          <a:xfrm>
            <a:off x="1351877" y="5428649"/>
            <a:ext cx="0" cy="499625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2A762AF3-349B-4457-BA55-09F3DF8A6E19}"/>
              </a:ext>
            </a:extLst>
          </p:cNvPr>
          <p:cNvCxnSpPr/>
          <p:nvPr/>
        </p:nvCxnSpPr>
        <p:spPr>
          <a:xfrm>
            <a:off x="6209479" y="5428649"/>
            <a:ext cx="0" cy="499625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F5DEEECC-0683-416F-9D16-EE49C83E7172}"/>
              </a:ext>
            </a:extLst>
          </p:cNvPr>
          <p:cNvCxnSpPr/>
          <p:nvPr/>
        </p:nvCxnSpPr>
        <p:spPr>
          <a:xfrm>
            <a:off x="1351877" y="7307469"/>
            <a:ext cx="0" cy="288000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FDA257AC-479E-49F6-9799-8E397798BE4E}"/>
              </a:ext>
            </a:extLst>
          </p:cNvPr>
          <p:cNvCxnSpPr/>
          <p:nvPr/>
        </p:nvCxnSpPr>
        <p:spPr>
          <a:xfrm>
            <a:off x="3918701" y="6597702"/>
            <a:ext cx="0" cy="997767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F3AFEF6A-280E-4443-8AAF-59EB3CD7B947}"/>
              </a:ext>
            </a:extLst>
          </p:cNvPr>
          <p:cNvCxnSpPr/>
          <p:nvPr/>
        </p:nvCxnSpPr>
        <p:spPr>
          <a:xfrm>
            <a:off x="6209385" y="6597702"/>
            <a:ext cx="0" cy="997767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FB32889D-B91B-4745-9519-8C1215990941}"/>
              </a:ext>
            </a:extLst>
          </p:cNvPr>
          <p:cNvGrpSpPr/>
          <p:nvPr/>
        </p:nvGrpSpPr>
        <p:grpSpPr>
          <a:xfrm>
            <a:off x="269919" y="8995332"/>
            <a:ext cx="7021425" cy="936001"/>
            <a:chOff x="141375" y="9560756"/>
            <a:chExt cx="8866795" cy="1181999"/>
          </a:xfrm>
        </p:grpSpPr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912D4754-37F0-4B72-8588-6B248CE4E6AE}"/>
                </a:ext>
              </a:extLst>
            </p:cNvPr>
            <p:cNvSpPr/>
            <p:nvPr/>
          </p:nvSpPr>
          <p:spPr>
            <a:xfrm>
              <a:off x="6275533" y="9560757"/>
              <a:ext cx="2732637" cy="118199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lvl="0" defTabSz="914400"/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Methodology: ELISA for pro-MMP-13</a:t>
              </a:r>
              <a:r>
                <a:rPr lang="en-US" sz="1100" b="1" kern="0" dirty="0">
                  <a:solidFill>
                    <a:srgbClr val="4B4B4B"/>
                  </a:solidFill>
                </a:rPr>
                <a:t>, real-time RT-qPCR for COL10A1, and measurement of enzymatic activity of alkaline phosphatase</a:t>
              </a:r>
              <a:endPara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21876912-30BF-4D49-A1BC-FB6EB4A4AE13}"/>
                </a:ext>
              </a:extLst>
            </p:cNvPr>
            <p:cNvSpPr/>
            <p:nvPr/>
          </p:nvSpPr>
          <p:spPr>
            <a:xfrm>
              <a:off x="141375" y="9560756"/>
              <a:ext cx="2732637" cy="118199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defTabSz="914400"/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Methodology: RNA-seq</a:t>
              </a:r>
              <a:r>
                <a:rPr lang="en-US" sz="1100" b="1" kern="0" dirty="0">
                  <a:solidFill>
                    <a:srgbClr val="4B4B4B"/>
                  </a:solidFill>
                </a:rPr>
                <a:t> and differential gene expression analysis</a:t>
              </a:r>
              <a:endPara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B500FF47-DB12-4AD2-B97A-BA9A60077EF7}"/>
                </a:ext>
              </a:extLst>
            </p:cNvPr>
            <p:cNvSpPr/>
            <p:nvPr/>
          </p:nvSpPr>
          <p:spPr>
            <a:xfrm>
              <a:off x="3382813" y="9560756"/>
              <a:ext cx="2732637" cy="1181998"/>
            </a:xfrm>
            <a:prstGeom prst="rect">
              <a:avLst/>
            </a:prstGeom>
            <a:gradFill rotWithShape="1">
              <a:gsLst>
                <a:gs pos="0">
                  <a:srgbClr val="9C9C9C">
                    <a:tint val="50000"/>
                    <a:satMod val="300000"/>
                  </a:srgbClr>
                </a:gs>
                <a:gs pos="35000">
                  <a:srgbClr val="9C9C9C">
                    <a:tint val="37000"/>
                    <a:satMod val="300000"/>
                  </a:srgbClr>
                </a:gs>
                <a:gs pos="100000">
                  <a:srgbClr val="9C9C9C">
                    <a:tint val="15000"/>
                    <a:satMod val="350000"/>
                  </a:srgbClr>
                </a:gs>
              </a:gsLst>
              <a:lin ang="16200000" scaled="1"/>
            </a:gradFill>
            <a:ln w="9525" cap="flat" cmpd="sng" algn="ctr">
              <a:solidFill>
                <a:srgbClr val="9C9C9C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lvl="0" defTabSz="914400"/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rgbClr val="4B4B4B"/>
                  </a:solidFill>
                  <a:effectLst/>
                  <a:uLnTx/>
                  <a:uFillTx/>
                  <a:ea typeface="+mn-ea"/>
                  <a:cs typeface="+mn-cs"/>
                </a:rPr>
                <a:t>Methodology: </a:t>
              </a:r>
              <a:r>
                <a:rPr lang="en-US" sz="1100" b="1" kern="0" dirty="0">
                  <a:solidFill>
                    <a:srgbClr val="4B4B4B"/>
                  </a:solidFill>
                </a:rPr>
                <a:t>ELISA for CCN1, aggrecan and type II collagen pro-peptide</a:t>
              </a:r>
              <a:endPara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rgbClr val="4B4B4B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</p:grp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id="{21FC9551-455A-4876-9C89-A783092A6522}"/>
              </a:ext>
            </a:extLst>
          </p:cNvPr>
          <p:cNvCxnSpPr/>
          <p:nvPr/>
        </p:nvCxnSpPr>
        <p:spPr>
          <a:xfrm>
            <a:off x="1351877" y="8514723"/>
            <a:ext cx="0" cy="396000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BDB4C7EE-7C0E-4D01-9309-90FDA422BE25}"/>
              </a:ext>
            </a:extLst>
          </p:cNvPr>
          <p:cNvCxnSpPr/>
          <p:nvPr/>
        </p:nvCxnSpPr>
        <p:spPr>
          <a:xfrm>
            <a:off x="6209934" y="8514723"/>
            <a:ext cx="0" cy="396000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448A8AF0-16BE-4CE5-B080-39100DF52EEE}"/>
              </a:ext>
            </a:extLst>
          </p:cNvPr>
          <p:cNvCxnSpPr/>
          <p:nvPr/>
        </p:nvCxnSpPr>
        <p:spPr>
          <a:xfrm>
            <a:off x="3917277" y="8514723"/>
            <a:ext cx="0" cy="396000"/>
          </a:xfrm>
          <a:prstGeom prst="straightConnector1">
            <a:avLst/>
          </a:prstGeom>
          <a:noFill/>
          <a:ln w="28575" cap="flat" cmpd="sng" algn="ctr">
            <a:solidFill>
              <a:srgbClr val="4B4B4B"/>
            </a:solidFill>
            <a:prstDash val="solid"/>
            <a:tailEnd type="triangle"/>
          </a:ln>
          <a:effectLst/>
        </p:spPr>
      </p:cxn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9614" y="64893"/>
            <a:ext cx="1383912" cy="493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8555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28DA622-FEBC-46D3-B163-38CE1C2B6C54}"/>
              </a:ext>
            </a:extLst>
          </p:cNvPr>
          <p:cNvSpPr/>
          <p:nvPr/>
        </p:nvSpPr>
        <p:spPr>
          <a:xfrm>
            <a:off x="179512" y="479376"/>
            <a:ext cx="7173788" cy="2123658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3: Study flow diagram.  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n of the 19 articular cartilage samples obtained were used for the transcriptome analysis. Ten monolayer cultures were generated from these samples, and each culture was treated with 6 different treatment conditions. Each condition was performed in triplicates. Sample collection took place 24 h after incubation. 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protein analysis, the remaining 9 articular cartilage samples were used to prepare 6 monolayer and 4 alginate beads 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ulture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rom 4 patients sufficient cell numbers allowed generation of both monolayer and alginate beads cultures. Each culture was treated with 2 different treatment conditions and each condition was performed in triplicates. For monolayer cultures, sample collection took place 24 h and 72 h after incubation and, for alginate beads culture, samples were collected from 8 different time points.  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For some cultures two samples were poole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have enough cells to produce beads for all culture conditions and time points of sample collec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5604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Finished xmlns="059fc547-a1e4-4b8d-82b9-78eec4423d84">false</Finished>
    <_Status xmlns="http://schemas.microsoft.com/sharepoint/v3/fields">Not Started</_Status>
    <TaxCatchAll xmlns="059fc547-a1e4-4b8d-82b9-78eec4423d84"/>
    <TaxKeywordTaxHTField xmlns="059fc547-a1e4-4b8d-82b9-78eec4423d84">
      <Terms xmlns="http://schemas.microsoft.com/office/infopath/2007/PartnerControls"/>
    </TaxKeywordTaxHTField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D96A27105234489861BEF6E86B06D4" ma:contentTypeVersion="22" ma:contentTypeDescription="Create a new document." ma:contentTypeScope="" ma:versionID="dca18c0433d84dd0ea16714a5807ab0b">
  <xsd:schema xmlns:xsd="http://www.w3.org/2001/XMLSchema" xmlns:xs="http://www.w3.org/2001/XMLSchema" xmlns:p="http://schemas.microsoft.com/office/2006/metadata/properties" xmlns:ns2="http://schemas.microsoft.com/sharepoint/v3/fields" xmlns:ns3="059fc547-a1e4-4b8d-82b9-78eec4423d84" xmlns:ns4="4762b03c-6c27-4192-848d-cb0b6cbee78a" targetNamespace="http://schemas.microsoft.com/office/2006/metadata/properties" ma:root="true" ma:fieldsID="51cc04f524575326c24ee35f3d2aec87" ns2:_="" ns3:_="" ns4:_="">
    <xsd:import namespace="http://schemas.microsoft.com/sharepoint/v3/fields"/>
    <xsd:import namespace="059fc547-a1e4-4b8d-82b9-78eec4423d84"/>
    <xsd:import namespace="4762b03c-6c27-4192-848d-cb0b6cbee78a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3:Finished" minOccurs="0"/>
                <xsd:element ref="ns3:TaxKeywordTaxHTField" minOccurs="0"/>
                <xsd:element ref="ns3:TaxCatchAll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3:SharedWithUsers" minOccurs="0"/>
                <xsd:element ref="ns3:SharedWithDetails" minOccurs="0"/>
                <xsd:element ref="ns4:MediaServiceDateTaken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format="Dropdown" ma:internalName="_Status" ma:readOnly="false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59fc547-a1e4-4b8d-82b9-78eec4423d84" elementFormDefault="qualified">
    <xsd:import namespace="http://schemas.microsoft.com/office/2006/documentManagement/types"/>
    <xsd:import namespace="http://schemas.microsoft.com/office/infopath/2007/PartnerControls"/>
    <xsd:element name="Finished" ma:index="9" nillable="true" ma:displayName="Finished" ma:default="0" ma:internalName="Finished" ma:readOnly="false">
      <xsd:simpleType>
        <xsd:restriction base="dms:Boolean"/>
      </xsd:simpleType>
    </xsd:element>
    <xsd:element name="TaxKeywordTaxHTField" ma:index="11" nillable="true" ma:taxonomy="true" ma:internalName="TaxKeywordTaxHTField" ma:taxonomyFieldName="TaxKeyword" ma:displayName="Enterprise Keywords" ma:fieldId="{23f27201-bee3-471e-b2e7-b64fd8b7ca38}" ma:taxonomyMulti="true" ma:sspId="1f131a42-a101-40b7-aecc-f7ea1becb290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TaxCatchAll" ma:index="12" nillable="true" ma:displayName="Taxonomy Catch All Column" ma:hidden="true" ma:list="{e4773684-3804-47dc-bc9e-0ebedeee6c79}" ma:internalName="TaxCatchAll" ma:showField="CatchAllData" ma:web="059fc547-a1e4-4b8d-82b9-78eec4423d8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62b03c-6c27-4192-848d-cb0b6cbee78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2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7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C7B4A23-4C51-4D5D-895C-8B507EBA4407}">
  <ds:schemaRefs>
    <ds:schemaRef ds:uri="http://schemas.microsoft.com/office/2006/metadata/properties"/>
    <ds:schemaRef ds:uri="http://schemas.microsoft.com/office/infopath/2007/PartnerControls"/>
    <ds:schemaRef ds:uri="059fc547-a1e4-4b8d-82b9-78eec4423d84"/>
    <ds:schemaRef ds:uri="http://schemas.microsoft.com/sharepoint/v3/fields"/>
  </ds:schemaRefs>
</ds:datastoreItem>
</file>

<file path=customXml/itemProps2.xml><?xml version="1.0" encoding="utf-8"?>
<ds:datastoreItem xmlns:ds="http://schemas.openxmlformats.org/officeDocument/2006/customXml" ds:itemID="{56B57A05-9D9F-4589-BDE7-E4F433E8518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059fc547-a1e4-4b8d-82b9-78eec4423d84"/>
    <ds:schemaRef ds:uri="4762b03c-6c27-4192-848d-cb0b6cbee78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70F5CCC-8C49-43B4-A523-77DB8C2DB20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5</Words>
  <Application>Microsoft Office PowerPoint</Application>
  <PresentationFormat>Custom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er, Dr. Kathrin</dc:creator>
  <cp:keywords/>
  <cp:lastModifiedBy>Hemmer, Dr. Kathrin</cp:lastModifiedBy>
  <cp:revision>27</cp:revision>
  <dcterms:created xsi:type="dcterms:W3CDTF">2020-06-25T12:24:12Z</dcterms:created>
  <dcterms:modified xsi:type="dcterms:W3CDTF">2021-03-29T10:05:57Z</dcterms:modified>
  <cp:contentStatus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D96A27105234489861BEF6E86B06D4</vt:lpwstr>
  </property>
  <property fmtid="{D5CDD505-2E9C-101B-9397-08002B2CF9AE}" pid="3" name="TaxKeyword">
    <vt:lpwstr/>
  </property>
</Properties>
</file>